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860C918-5677-4534-9C33-A8599B874937}" v="22" dt="2024-09-12T17:38:14.88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0867" autoAdjust="0"/>
    <p:restoredTop sz="93883" autoAdjust="0"/>
  </p:normalViewPr>
  <p:slideViewPr>
    <p:cSldViewPr snapToGrid="0">
      <p:cViewPr varScale="1">
        <p:scale>
          <a:sx n="113" d="100"/>
          <a:sy n="113" d="100"/>
        </p:scale>
        <p:origin x="115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A RUIZ PADILLA" userId="f76b708f-9ed5-4a9f-836a-f5694ea915d2" providerId="ADAL" clId="{D860C918-5677-4534-9C33-A8599B874937}"/>
    <pc:docChg chg="undo custSel addSld delSld modSld">
      <pc:chgData name="ANA RUIZ PADILLA" userId="f76b708f-9ed5-4a9f-836a-f5694ea915d2" providerId="ADAL" clId="{D860C918-5677-4534-9C33-A8599B874937}" dt="2024-09-12T17:38:31.973" v="318" actId="47"/>
      <pc:docMkLst>
        <pc:docMk/>
      </pc:docMkLst>
      <pc:sldChg chg="addSp delSp modSp del mod">
        <pc:chgData name="ANA RUIZ PADILLA" userId="f76b708f-9ed5-4a9f-836a-f5694ea915d2" providerId="ADAL" clId="{D860C918-5677-4534-9C33-A8599B874937}" dt="2024-09-12T17:38:31.119" v="317" actId="47"/>
        <pc:sldMkLst>
          <pc:docMk/>
          <pc:sldMk cId="1952055128" sldId="256"/>
        </pc:sldMkLst>
        <pc:spChg chg="add mod">
          <ac:chgData name="ANA RUIZ PADILLA" userId="f76b708f-9ed5-4a9f-836a-f5694ea915d2" providerId="ADAL" clId="{D860C918-5677-4534-9C33-A8599B874937}" dt="2024-09-02T17:03:47.673" v="124" actId="14100"/>
          <ac:spMkLst>
            <pc:docMk/>
            <pc:sldMk cId="1952055128" sldId="256"/>
            <ac:spMk id="18" creationId="{ED2D265F-CAF7-55B4-9548-6BF681A80B62}"/>
          </ac:spMkLst>
        </pc:spChg>
        <pc:graphicFrameChg chg="add del">
          <ac:chgData name="ANA RUIZ PADILLA" userId="f76b708f-9ed5-4a9f-836a-f5694ea915d2" providerId="ADAL" clId="{D860C918-5677-4534-9C33-A8599B874937}" dt="2024-09-12T16:31:11.167" v="134" actId="478"/>
          <ac:graphicFrameMkLst>
            <pc:docMk/>
            <pc:sldMk cId="1952055128" sldId="256"/>
            <ac:graphicFrameMk id="2" creationId="{9F1A0044-4721-50F2-6F32-61369D9DAEC4}"/>
          </ac:graphicFrameMkLst>
        </pc:graphicFrameChg>
      </pc:sldChg>
      <pc:sldChg chg="addSp delSp modSp new del mod">
        <pc:chgData name="ANA RUIZ PADILLA" userId="f76b708f-9ed5-4a9f-836a-f5694ea915d2" providerId="ADAL" clId="{D860C918-5677-4534-9C33-A8599B874937}" dt="2024-09-12T17:38:25.854" v="316" actId="47"/>
        <pc:sldMkLst>
          <pc:docMk/>
          <pc:sldMk cId="3360037552" sldId="257"/>
        </pc:sldMkLst>
        <pc:spChg chg="del">
          <ac:chgData name="ANA RUIZ PADILLA" userId="f76b708f-9ed5-4a9f-836a-f5694ea915d2" providerId="ADAL" clId="{D860C918-5677-4534-9C33-A8599B874937}" dt="2024-09-12T16:30:39.088" v="127" actId="478"/>
          <ac:spMkLst>
            <pc:docMk/>
            <pc:sldMk cId="3360037552" sldId="257"/>
            <ac:spMk id="2" creationId="{7BE3E6B9-B8FA-4BF8-7B11-616EFAC98B5B}"/>
          </ac:spMkLst>
        </pc:spChg>
        <pc:spChg chg="del">
          <ac:chgData name="ANA RUIZ PADILLA" userId="f76b708f-9ed5-4a9f-836a-f5694ea915d2" providerId="ADAL" clId="{D860C918-5677-4534-9C33-A8599B874937}" dt="2024-09-12T16:30:38.010" v="126" actId="478"/>
          <ac:spMkLst>
            <pc:docMk/>
            <pc:sldMk cId="3360037552" sldId="257"/>
            <ac:spMk id="3" creationId="{C615DDE6-478C-E3C7-7403-B8C695A4DECB}"/>
          </ac:spMkLst>
        </pc:spChg>
        <pc:spChg chg="add mod">
          <ac:chgData name="ANA RUIZ PADILLA" userId="f76b708f-9ed5-4a9f-836a-f5694ea915d2" providerId="ADAL" clId="{D860C918-5677-4534-9C33-A8599B874937}" dt="2024-09-12T17:31:39.653" v="153" actId="1076"/>
          <ac:spMkLst>
            <pc:docMk/>
            <pc:sldMk cId="3360037552" sldId="257"/>
            <ac:spMk id="7" creationId="{1BDA1F7B-B94C-ED2A-174D-CC72386ED37D}"/>
          </ac:spMkLst>
        </pc:spChg>
        <pc:spChg chg="add mod">
          <ac:chgData name="ANA RUIZ PADILLA" userId="f76b708f-9ed5-4a9f-836a-f5694ea915d2" providerId="ADAL" clId="{D860C918-5677-4534-9C33-A8599B874937}" dt="2024-09-12T17:32:31.923" v="191" actId="20577"/>
          <ac:spMkLst>
            <pc:docMk/>
            <pc:sldMk cId="3360037552" sldId="257"/>
            <ac:spMk id="8" creationId="{C291C666-B6F2-B474-E327-F2592A365778}"/>
          </ac:spMkLst>
        </pc:spChg>
        <pc:spChg chg="add mod">
          <ac:chgData name="ANA RUIZ PADILLA" userId="f76b708f-9ed5-4a9f-836a-f5694ea915d2" providerId="ADAL" clId="{D860C918-5677-4534-9C33-A8599B874937}" dt="2024-09-12T17:32:58.025" v="207" actId="20577"/>
          <ac:spMkLst>
            <pc:docMk/>
            <pc:sldMk cId="3360037552" sldId="257"/>
            <ac:spMk id="10" creationId="{2DE02384-BC50-5CC5-C900-0CB49875E76B}"/>
          </ac:spMkLst>
        </pc:spChg>
        <pc:spChg chg="add mod">
          <ac:chgData name="ANA RUIZ PADILLA" userId="f76b708f-9ed5-4a9f-836a-f5694ea915d2" providerId="ADAL" clId="{D860C918-5677-4534-9C33-A8599B874937}" dt="2024-09-12T17:33:42.006" v="219" actId="1076"/>
          <ac:spMkLst>
            <pc:docMk/>
            <pc:sldMk cId="3360037552" sldId="257"/>
            <ac:spMk id="12" creationId="{574AA884-BA7B-FBE8-D95B-9D9BDCDF6B3C}"/>
          </ac:spMkLst>
        </pc:spChg>
        <pc:spChg chg="add mod">
          <ac:chgData name="ANA RUIZ PADILLA" userId="f76b708f-9ed5-4a9f-836a-f5694ea915d2" providerId="ADAL" clId="{D860C918-5677-4534-9C33-A8599B874937}" dt="2024-09-12T17:34:22.005" v="231" actId="122"/>
          <ac:spMkLst>
            <pc:docMk/>
            <pc:sldMk cId="3360037552" sldId="257"/>
            <ac:spMk id="14" creationId="{E0DF88E1-013C-CB6B-9024-CE8FC215D795}"/>
          </ac:spMkLst>
        </pc:spChg>
        <pc:spChg chg="add mod">
          <ac:chgData name="ANA RUIZ PADILLA" userId="f76b708f-9ed5-4a9f-836a-f5694ea915d2" providerId="ADAL" clId="{D860C918-5677-4534-9C33-A8599B874937}" dt="2024-09-12T17:36:36.013" v="285"/>
          <ac:spMkLst>
            <pc:docMk/>
            <pc:sldMk cId="3360037552" sldId="257"/>
            <ac:spMk id="16" creationId="{46CD0191-8768-AD1D-A3B5-201CAABA06B3}"/>
          </ac:spMkLst>
        </pc:spChg>
        <pc:spChg chg="add mod">
          <ac:chgData name="ANA RUIZ PADILLA" userId="f76b708f-9ed5-4a9f-836a-f5694ea915d2" providerId="ADAL" clId="{D860C918-5677-4534-9C33-A8599B874937}" dt="2024-09-12T17:36:39.936" v="287" actId="1076"/>
          <ac:spMkLst>
            <pc:docMk/>
            <pc:sldMk cId="3360037552" sldId="257"/>
            <ac:spMk id="18" creationId="{E369149A-AB07-5750-84DE-C724B9D74838}"/>
          </ac:spMkLst>
        </pc:spChg>
        <pc:graphicFrameChg chg="add mod modGraphic">
          <ac:chgData name="ANA RUIZ PADILLA" userId="f76b708f-9ed5-4a9f-836a-f5694ea915d2" providerId="ADAL" clId="{D860C918-5677-4534-9C33-A8599B874937}" dt="2024-09-12T17:32:19.401" v="158" actId="6549"/>
          <ac:graphicFrameMkLst>
            <pc:docMk/>
            <pc:sldMk cId="3360037552" sldId="257"/>
            <ac:graphicFrameMk id="4" creationId="{B0077650-05A2-543B-095E-B5EE0A9B0FD7}"/>
          </ac:graphicFrameMkLst>
        </pc:graphicFrameChg>
        <pc:picChg chg="add mod">
          <ac:chgData name="ANA RUIZ PADILLA" userId="f76b708f-9ed5-4a9f-836a-f5694ea915d2" providerId="ADAL" clId="{D860C918-5677-4534-9C33-A8599B874937}" dt="2024-09-12T17:31:36.955" v="152" actId="1076"/>
          <ac:picMkLst>
            <pc:docMk/>
            <pc:sldMk cId="3360037552" sldId="257"/>
            <ac:picMk id="5" creationId="{0CE50342-AE74-1472-2E8E-A46EB005AFCD}"/>
          </ac:picMkLst>
        </pc:picChg>
        <pc:picChg chg="add mod modCrop">
          <ac:chgData name="ANA RUIZ PADILLA" userId="f76b708f-9ed5-4a9f-836a-f5694ea915d2" providerId="ADAL" clId="{D860C918-5677-4534-9C33-A8599B874937}" dt="2024-09-12T17:31:48.905" v="156" actId="732"/>
          <ac:picMkLst>
            <pc:docMk/>
            <pc:sldMk cId="3360037552" sldId="257"/>
            <ac:picMk id="6" creationId="{5FDA4A64-FEFD-BFA2-BE0A-F04A22177628}"/>
          </ac:picMkLst>
        </pc:picChg>
        <pc:picChg chg="add mod modCrop">
          <ac:chgData name="ANA RUIZ PADILLA" userId="f76b708f-9ed5-4a9f-836a-f5694ea915d2" providerId="ADAL" clId="{D860C918-5677-4534-9C33-A8599B874937}" dt="2024-09-12T17:32:49.619" v="197" actId="1076"/>
          <ac:picMkLst>
            <pc:docMk/>
            <pc:sldMk cId="3360037552" sldId="257"/>
            <ac:picMk id="9" creationId="{373CF106-717C-26D5-5FB3-AF42901F6227}"/>
          </ac:picMkLst>
        </pc:picChg>
        <pc:picChg chg="add mod">
          <ac:chgData name="ANA RUIZ PADILLA" userId="f76b708f-9ed5-4a9f-836a-f5694ea915d2" providerId="ADAL" clId="{D860C918-5677-4534-9C33-A8599B874937}" dt="2024-09-12T17:33:20.583" v="213" actId="1076"/>
          <ac:picMkLst>
            <pc:docMk/>
            <pc:sldMk cId="3360037552" sldId="257"/>
            <ac:picMk id="11" creationId="{4A0AC9A1-4DB9-1E14-AE04-EBE5C7208337}"/>
          </ac:picMkLst>
        </pc:picChg>
        <pc:picChg chg="add mod">
          <ac:chgData name="ANA RUIZ PADILLA" userId="f76b708f-9ed5-4a9f-836a-f5694ea915d2" providerId="ADAL" clId="{D860C918-5677-4534-9C33-A8599B874937}" dt="2024-09-12T17:34:00.686" v="225" actId="1076"/>
          <ac:picMkLst>
            <pc:docMk/>
            <pc:sldMk cId="3360037552" sldId="257"/>
            <ac:picMk id="13" creationId="{96009A82-D1B8-865E-ABA8-AFEC4EA74191}"/>
          </ac:picMkLst>
        </pc:picChg>
        <pc:picChg chg="add mod">
          <ac:chgData name="ANA RUIZ PADILLA" userId="f76b708f-9ed5-4a9f-836a-f5694ea915d2" providerId="ADAL" clId="{D860C918-5677-4534-9C33-A8599B874937}" dt="2024-09-12T17:35:34.211" v="235" actId="1076"/>
          <ac:picMkLst>
            <pc:docMk/>
            <pc:sldMk cId="3360037552" sldId="257"/>
            <ac:picMk id="15" creationId="{AB59DA20-8B51-2642-DBF5-7F9C1D40CA2D}"/>
          </ac:picMkLst>
        </pc:picChg>
        <pc:picChg chg="add mod">
          <ac:chgData name="ANA RUIZ PADILLA" userId="f76b708f-9ed5-4a9f-836a-f5694ea915d2" providerId="ADAL" clId="{D860C918-5677-4534-9C33-A8599B874937}" dt="2024-09-12T17:36:31.070" v="283" actId="1076"/>
          <ac:picMkLst>
            <pc:docMk/>
            <pc:sldMk cId="3360037552" sldId="257"/>
            <ac:picMk id="17" creationId="{3B70F773-1595-2C23-B087-4A0321B8DFE2}"/>
          </ac:picMkLst>
        </pc:picChg>
      </pc:sldChg>
      <pc:sldChg chg="new del">
        <pc:chgData name="ANA RUIZ PADILLA" userId="f76b708f-9ed5-4a9f-836a-f5694ea915d2" providerId="ADAL" clId="{D860C918-5677-4534-9C33-A8599B874937}" dt="2024-09-12T17:38:31.973" v="318" actId="47"/>
        <pc:sldMkLst>
          <pc:docMk/>
          <pc:sldMk cId="1522098045" sldId="258"/>
        </pc:sldMkLst>
      </pc:sldChg>
      <pc:sldChg chg="addSp delSp modSp add mod">
        <pc:chgData name="ANA RUIZ PADILLA" userId="f76b708f-9ed5-4a9f-836a-f5694ea915d2" providerId="ADAL" clId="{D860C918-5677-4534-9C33-A8599B874937}" dt="2024-09-12T17:38:17.680" v="314" actId="1076"/>
        <pc:sldMkLst>
          <pc:docMk/>
          <pc:sldMk cId="2927637485" sldId="259"/>
        </pc:sldMkLst>
        <pc:spChg chg="del">
          <ac:chgData name="ANA RUIZ PADILLA" userId="f76b708f-9ed5-4a9f-836a-f5694ea915d2" providerId="ADAL" clId="{D860C918-5677-4534-9C33-A8599B874937}" dt="2024-09-12T17:37:17.786" v="299" actId="478"/>
          <ac:spMkLst>
            <pc:docMk/>
            <pc:sldMk cId="2927637485" sldId="259"/>
            <ac:spMk id="12" creationId="{574AA884-BA7B-FBE8-D95B-9D9BDCDF6B3C}"/>
          </ac:spMkLst>
        </pc:spChg>
        <pc:spChg chg="del">
          <ac:chgData name="ANA RUIZ PADILLA" userId="f76b708f-9ed5-4a9f-836a-f5694ea915d2" providerId="ADAL" clId="{D860C918-5677-4534-9C33-A8599B874937}" dt="2024-09-12T17:37:17.786" v="299" actId="478"/>
          <ac:spMkLst>
            <pc:docMk/>
            <pc:sldMk cId="2927637485" sldId="259"/>
            <ac:spMk id="14" creationId="{E0DF88E1-013C-CB6B-9024-CE8FC215D795}"/>
          </ac:spMkLst>
        </pc:spChg>
        <pc:spChg chg="del">
          <ac:chgData name="ANA RUIZ PADILLA" userId="f76b708f-9ed5-4a9f-836a-f5694ea915d2" providerId="ADAL" clId="{D860C918-5677-4534-9C33-A8599B874937}" dt="2024-09-12T17:37:17.786" v="299" actId="478"/>
          <ac:spMkLst>
            <pc:docMk/>
            <pc:sldMk cId="2927637485" sldId="259"/>
            <ac:spMk id="16" creationId="{46CD0191-8768-AD1D-A3B5-201CAABA06B3}"/>
          </ac:spMkLst>
        </pc:spChg>
        <pc:spChg chg="del">
          <ac:chgData name="ANA RUIZ PADILLA" userId="f76b708f-9ed5-4a9f-836a-f5694ea915d2" providerId="ADAL" clId="{D860C918-5677-4534-9C33-A8599B874937}" dt="2024-09-12T17:37:17.786" v="299" actId="478"/>
          <ac:spMkLst>
            <pc:docMk/>
            <pc:sldMk cId="2927637485" sldId="259"/>
            <ac:spMk id="18" creationId="{E369149A-AB07-5750-84DE-C724B9D74838}"/>
          </ac:spMkLst>
        </pc:spChg>
        <pc:spChg chg="add mod">
          <ac:chgData name="ANA RUIZ PADILLA" userId="f76b708f-9ed5-4a9f-836a-f5694ea915d2" providerId="ADAL" clId="{D860C918-5677-4534-9C33-A8599B874937}" dt="2024-09-12T17:38:17.680" v="314" actId="1076"/>
          <ac:spMkLst>
            <pc:docMk/>
            <pc:sldMk cId="2927637485" sldId="259"/>
            <ac:spMk id="19" creationId="{23EEF46F-B9C1-B317-2E42-C5EA1531834B}"/>
          </ac:spMkLst>
        </pc:spChg>
        <pc:spChg chg="add mod">
          <ac:chgData name="ANA RUIZ PADILLA" userId="f76b708f-9ed5-4a9f-836a-f5694ea915d2" providerId="ADAL" clId="{D860C918-5677-4534-9C33-A8599B874937}" dt="2024-09-12T17:38:17.680" v="314" actId="1076"/>
          <ac:spMkLst>
            <pc:docMk/>
            <pc:sldMk cId="2927637485" sldId="259"/>
            <ac:spMk id="21" creationId="{E944A4F5-7DA2-94C7-F788-E3293C39E517}"/>
          </ac:spMkLst>
        </pc:spChg>
        <pc:spChg chg="add mod">
          <ac:chgData name="ANA RUIZ PADILLA" userId="f76b708f-9ed5-4a9f-836a-f5694ea915d2" providerId="ADAL" clId="{D860C918-5677-4534-9C33-A8599B874937}" dt="2024-09-12T17:38:17.680" v="314" actId="1076"/>
          <ac:spMkLst>
            <pc:docMk/>
            <pc:sldMk cId="2927637485" sldId="259"/>
            <ac:spMk id="23" creationId="{901D34D8-B84B-A25E-D376-E858E692C1CF}"/>
          </ac:spMkLst>
        </pc:spChg>
        <pc:spChg chg="add mod">
          <ac:chgData name="ANA RUIZ PADILLA" userId="f76b708f-9ed5-4a9f-836a-f5694ea915d2" providerId="ADAL" clId="{D860C918-5677-4534-9C33-A8599B874937}" dt="2024-09-12T17:38:17.680" v="314" actId="1076"/>
          <ac:spMkLst>
            <pc:docMk/>
            <pc:sldMk cId="2927637485" sldId="259"/>
            <ac:spMk id="25" creationId="{6C876F34-324C-D313-E08A-A9385122A24E}"/>
          </ac:spMkLst>
        </pc:spChg>
        <pc:graphicFrameChg chg="add mod">
          <ac:chgData name="ANA RUIZ PADILLA" userId="f76b708f-9ed5-4a9f-836a-f5694ea915d2" providerId="ADAL" clId="{D860C918-5677-4534-9C33-A8599B874937}" dt="2024-09-12T17:38:17.680" v="314" actId="1076"/>
          <ac:graphicFrameMkLst>
            <pc:docMk/>
            <pc:sldMk cId="2927637485" sldId="259"/>
            <ac:graphicFrameMk id="2" creationId="{F3B7C61B-847D-2EAC-86EA-E698449F408F}"/>
          </ac:graphicFrameMkLst>
        </pc:graphicFrameChg>
        <pc:graphicFrameChg chg="modGraphic">
          <ac:chgData name="ANA RUIZ PADILLA" userId="f76b708f-9ed5-4a9f-836a-f5694ea915d2" providerId="ADAL" clId="{D860C918-5677-4534-9C33-A8599B874937}" dt="2024-09-12T17:36:53.544" v="290" actId="2165"/>
          <ac:graphicFrameMkLst>
            <pc:docMk/>
            <pc:sldMk cId="2927637485" sldId="259"/>
            <ac:graphicFrameMk id="4" creationId="{B0077650-05A2-543B-095E-B5EE0A9B0FD7}"/>
          </ac:graphicFrameMkLst>
        </pc:graphicFrameChg>
        <pc:picChg chg="add mod">
          <ac:chgData name="ANA RUIZ PADILLA" userId="f76b708f-9ed5-4a9f-836a-f5694ea915d2" providerId="ADAL" clId="{D860C918-5677-4534-9C33-A8599B874937}" dt="2024-09-12T17:38:17.680" v="314" actId="1076"/>
          <ac:picMkLst>
            <pc:docMk/>
            <pc:sldMk cId="2927637485" sldId="259"/>
            <ac:picMk id="3" creationId="{CD8584C4-F34A-0074-78D6-663858A3713A}"/>
          </ac:picMkLst>
        </pc:picChg>
        <pc:picChg chg="add del">
          <ac:chgData name="ANA RUIZ PADILLA" userId="f76b708f-9ed5-4a9f-836a-f5694ea915d2" providerId="ADAL" clId="{D860C918-5677-4534-9C33-A8599B874937}" dt="2024-09-12T17:37:12.683" v="298" actId="478"/>
          <ac:picMkLst>
            <pc:docMk/>
            <pc:sldMk cId="2927637485" sldId="259"/>
            <ac:picMk id="11" creationId="{4A0AC9A1-4DB9-1E14-AE04-EBE5C7208337}"/>
          </ac:picMkLst>
        </pc:picChg>
        <pc:picChg chg="add del">
          <ac:chgData name="ANA RUIZ PADILLA" userId="f76b708f-9ed5-4a9f-836a-f5694ea915d2" providerId="ADAL" clId="{D860C918-5677-4534-9C33-A8599B874937}" dt="2024-09-12T17:37:17.786" v="299" actId="478"/>
          <ac:picMkLst>
            <pc:docMk/>
            <pc:sldMk cId="2927637485" sldId="259"/>
            <ac:picMk id="13" creationId="{96009A82-D1B8-865E-ABA8-AFEC4EA74191}"/>
          </ac:picMkLst>
        </pc:picChg>
        <pc:picChg chg="del">
          <ac:chgData name="ANA RUIZ PADILLA" userId="f76b708f-9ed5-4a9f-836a-f5694ea915d2" providerId="ADAL" clId="{D860C918-5677-4534-9C33-A8599B874937}" dt="2024-09-12T17:37:17.786" v="299" actId="478"/>
          <ac:picMkLst>
            <pc:docMk/>
            <pc:sldMk cId="2927637485" sldId="259"/>
            <ac:picMk id="15" creationId="{AB59DA20-8B51-2642-DBF5-7F9C1D40CA2D}"/>
          </ac:picMkLst>
        </pc:picChg>
        <pc:picChg chg="add del">
          <ac:chgData name="ANA RUIZ PADILLA" userId="f76b708f-9ed5-4a9f-836a-f5694ea915d2" providerId="ADAL" clId="{D860C918-5677-4534-9C33-A8599B874937}" dt="2024-09-12T17:37:17.786" v="299" actId="478"/>
          <ac:picMkLst>
            <pc:docMk/>
            <pc:sldMk cId="2927637485" sldId="259"/>
            <ac:picMk id="17" creationId="{3B70F773-1595-2C23-B087-4A0321B8DFE2}"/>
          </ac:picMkLst>
        </pc:picChg>
        <pc:picChg chg="add mod">
          <ac:chgData name="ANA RUIZ PADILLA" userId="f76b708f-9ed5-4a9f-836a-f5694ea915d2" providerId="ADAL" clId="{D860C918-5677-4534-9C33-A8599B874937}" dt="2024-09-12T17:38:17.680" v="314" actId="1076"/>
          <ac:picMkLst>
            <pc:docMk/>
            <pc:sldMk cId="2927637485" sldId="259"/>
            <ac:picMk id="20" creationId="{4D3024D9-41B0-0544-CD06-7B3D3C62F9D5}"/>
          </ac:picMkLst>
        </pc:picChg>
        <pc:picChg chg="add mod">
          <ac:chgData name="ANA RUIZ PADILLA" userId="f76b708f-9ed5-4a9f-836a-f5694ea915d2" providerId="ADAL" clId="{D860C918-5677-4534-9C33-A8599B874937}" dt="2024-09-12T17:38:17.680" v="314" actId="1076"/>
          <ac:picMkLst>
            <pc:docMk/>
            <pc:sldMk cId="2927637485" sldId="259"/>
            <ac:picMk id="22" creationId="{39A811CB-DB12-D6CD-C921-5E055C5DBC9B}"/>
          </ac:picMkLst>
        </pc:picChg>
        <pc:picChg chg="add mod">
          <ac:chgData name="ANA RUIZ PADILLA" userId="f76b708f-9ed5-4a9f-836a-f5694ea915d2" providerId="ADAL" clId="{D860C918-5677-4534-9C33-A8599B874937}" dt="2024-09-12T17:38:17.680" v="314" actId="1076"/>
          <ac:picMkLst>
            <pc:docMk/>
            <pc:sldMk cId="2927637485" sldId="259"/>
            <ac:picMk id="24" creationId="{BCA99AB5-49B9-0F2A-91D1-B5D4B13FC3E8}"/>
          </ac:picMkLst>
        </pc:picChg>
      </pc:sldChg>
      <pc:sldChg chg="delSp modSp add del mod">
        <pc:chgData name="ANA RUIZ PADILLA" userId="f76b708f-9ed5-4a9f-836a-f5694ea915d2" providerId="ADAL" clId="{D860C918-5677-4534-9C33-A8599B874937}" dt="2024-09-12T17:38:23.135" v="315" actId="47"/>
        <pc:sldMkLst>
          <pc:docMk/>
          <pc:sldMk cId="2617110491" sldId="260"/>
        </pc:sldMkLst>
        <pc:spChg chg="del">
          <ac:chgData name="ANA RUIZ PADILLA" userId="f76b708f-9ed5-4a9f-836a-f5694ea915d2" providerId="ADAL" clId="{D860C918-5677-4534-9C33-A8599B874937}" dt="2024-09-12T17:37:58.932" v="305" actId="478"/>
          <ac:spMkLst>
            <pc:docMk/>
            <pc:sldMk cId="2617110491" sldId="260"/>
            <ac:spMk id="7" creationId="{1BDA1F7B-B94C-ED2A-174D-CC72386ED37D}"/>
          </ac:spMkLst>
        </pc:spChg>
        <pc:spChg chg="del">
          <ac:chgData name="ANA RUIZ PADILLA" userId="f76b708f-9ed5-4a9f-836a-f5694ea915d2" providerId="ADAL" clId="{D860C918-5677-4534-9C33-A8599B874937}" dt="2024-09-12T17:38:00.106" v="307" actId="478"/>
          <ac:spMkLst>
            <pc:docMk/>
            <pc:sldMk cId="2617110491" sldId="260"/>
            <ac:spMk id="8" creationId="{C291C666-B6F2-B474-E327-F2592A365778}"/>
          </ac:spMkLst>
        </pc:spChg>
        <pc:spChg chg="del">
          <ac:chgData name="ANA RUIZ PADILLA" userId="f76b708f-9ed5-4a9f-836a-f5694ea915d2" providerId="ADAL" clId="{D860C918-5677-4534-9C33-A8599B874937}" dt="2024-09-12T17:38:02.173" v="309" actId="478"/>
          <ac:spMkLst>
            <pc:docMk/>
            <pc:sldMk cId="2617110491" sldId="260"/>
            <ac:spMk id="10" creationId="{2DE02384-BC50-5CC5-C900-0CB49875E76B}"/>
          </ac:spMkLst>
        </pc:spChg>
        <pc:graphicFrameChg chg="mod modGraphic">
          <ac:chgData name="ANA RUIZ PADILLA" userId="f76b708f-9ed5-4a9f-836a-f5694ea915d2" providerId="ADAL" clId="{D860C918-5677-4534-9C33-A8599B874937}" dt="2024-09-12T17:38:11.550" v="312" actId="1076"/>
          <ac:graphicFrameMkLst>
            <pc:docMk/>
            <pc:sldMk cId="2617110491" sldId="260"/>
            <ac:graphicFrameMk id="4" creationId="{B0077650-05A2-543B-095E-B5EE0A9B0FD7}"/>
          </ac:graphicFrameMkLst>
        </pc:graphicFrameChg>
        <pc:picChg chg="del">
          <ac:chgData name="ANA RUIZ PADILLA" userId="f76b708f-9ed5-4a9f-836a-f5694ea915d2" providerId="ADAL" clId="{D860C918-5677-4534-9C33-A8599B874937}" dt="2024-09-12T17:37:57.103" v="304" actId="478"/>
          <ac:picMkLst>
            <pc:docMk/>
            <pc:sldMk cId="2617110491" sldId="260"/>
            <ac:picMk id="5" creationId="{0CE50342-AE74-1472-2E8E-A46EB005AFCD}"/>
          </ac:picMkLst>
        </pc:picChg>
        <pc:picChg chg="del">
          <ac:chgData name="ANA RUIZ PADILLA" userId="f76b708f-9ed5-4a9f-836a-f5694ea915d2" providerId="ADAL" clId="{D860C918-5677-4534-9C33-A8599B874937}" dt="2024-09-12T17:37:59.379" v="306" actId="478"/>
          <ac:picMkLst>
            <pc:docMk/>
            <pc:sldMk cId="2617110491" sldId="260"/>
            <ac:picMk id="6" creationId="{5FDA4A64-FEFD-BFA2-BE0A-F04A22177628}"/>
          </ac:picMkLst>
        </pc:picChg>
        <pc:picChg chg="del">
          <ac:chgData name="ANA RUIZ PADILLA" userId="f76b708f-9ed5-4a9f-836a-f5694ea915d2" providerId="ADAL" clId="{D860C918-5677-4534-9C33-A8599B874937}" dt="2024-09-12T17:38:00.882" v="308" actId="478"/>
          <ac:picMkLst>
            <pc:docMk/>
            <pc:sldMk cId="2617110491" sldId="260"/>
            <ac:picMk id="9" creationId="{373CF106-717C-26D5-5FB3-AF42901F622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0F2C242-E410-B875-A34C-E409C41674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222D0B2-A36D-C5A5-CC08-BF33052CEA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EDCE6C1-F1D2-3089-1300-317EA4AE4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0EAEA61-29B5-94EB-536B-B91E7E856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EBD1BA8-A581-8F93-C160-44E1079F1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9849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7F9251A-8D8E-438C-DB64-D0742F5382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CFF69E4-F3CA-9D38-C78E-302DA2B858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3DE3F10-A278-930C-51B2-C201CB37C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902E0B1-1B0A-DB87-9745-F6A4BDA09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AF76098-D017-334B-8F11-ACDD2E0B3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968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E9BC020-5BB7-DFA6-7467-B2DA02D741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94EF391-4741-A826-1798-DDB673B1D8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CA894F8-573C-AC34-F6F5-E8287AF7A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9319798-1B34-8646-9287-4A080ABA9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C51EBEF-8CD2-B174-9487-ED20523B0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2765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377BA05-B07B-4E65-7D9C-19B82E0F7F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FBE1C55-A712-2862-D2F8-8BB8BEE1C1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63B5766-8563-5410-A58B-10B628A2D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DF3ACC-AAC2-5E19-CB70-F776BF85C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B46F4D0-31BF-BC35-FE73-DB2AFC6CA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8262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B9634B-D3FA-9C29-533B-8DB7057912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FED606C-7519-6A3E-DB6B-ED4FBE3934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99EF807-3589-F210-7855-571AB806A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AA788D2-1B36-4BC9-8EE6-F5616B344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39D8709-4823-9EC6-88D3-3603C1DCB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932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121191-C936-8C09-9921-380F4FF9A7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365BE72-4245-4F6E-0F38-324C14C79F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04D7BCB-5419-D8BD-C765-2DEBEE6B12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06F5D7A-FF38-E7D6-4540-C5276EE00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FA6B14B-2858-0920-BECD-2E1DE0B1E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8CEE4F9-0F3A-ADB8-6481-EE3F0B596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0385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BC0A7A9-2ED8-8DCD-45B1-B615D9C507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F0CECA9-7BA9-7431-F1A4-20D5A3CBEC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E1D670C-56EF-691C-3E86-CC0881ABEB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0E7950E-5151-8B4F-4A02-B39ECAD40F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DD53608-0BE9-1506-741B-0E9ECDCF91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87BEF17B-A836-D701-6A3F-76012D3D8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ADDB1CE-C558-DD76-FECF-BB36CE96E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45BFA2C-1AA6-15CE-0D7F-C6F0C3C39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2653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185697-29F8-7562-534A-71A0D91746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0BE8E42-F4F8-DC76-0C85-32083BC08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DC941741-FD26-8B7C-6C04-52367DB46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657751CC-EC75-BC43-7AAC-F236B0919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2382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8CD94C3-B017-A21C-B347-C91E35F84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25B7B14-E170-FB43-1C91-F352EC488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0E39E60-9404-1976-59AA-4C7E7C77B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6036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2DB0060-BA16-E614-4707-6242E8236C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3027EB2-70A6-1F6D-15E7-8C2F95AAD6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B637B20-BF80-7192-9A4E-3A455E40F7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4AA966F-623E-A8D6-3474-C6CB593D2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46FFBFD-31E9-E581-A160-7DED72CCB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2F401B3-8D9A-4752-41D7-71E5D021D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108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C32D65-47D7-FC5F-242A-DF247D019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75728C4-6EDE-8CC1-AC33-0821F3B72B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D41C1ED-1E9B-16D2-2F3F-B5B92CAE00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8556C87-03B0-EF4A-39F8-71B2A387B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6F6A933-12BD-AAB9-C8E9-BD4C59173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640CEAA-7210-CF02-A07E-9F8A0D6C2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7804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3A3D318-AB76-8200-4E3D-D47E4176B1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A8469A7-8997-B79C-EF1C-2020D2C373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6212F5C-08E4-047A-A397-A09D1CFD9F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19CA72-E449-405C-8537-0FD31F5FBB69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B7E536B-9A98-6DD2-F17B-85FC67DE85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11A402F-6BCE-FFDA-01AF-11BF205A64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3FA90A-624E-4816-B43A-E4F70126A8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362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B0077650-05A2-543B-095E-B5EE0A9B0F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2781964"/>
              </p:ext>
            </p:extLst>
          </p:nvPr>
        </p:nvGraphicFramePr>
        <p:xfrm>
          <a:off x="2032000" y="719666"/>
          <a:ext cx="8127999" cy="193147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968034331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3209201285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3354253266"/>
                    </a:ext>
                  </a:extLst>
                </a:gridCol>
              </a:tblGrid>
              <a:tr h="1931474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4907255"/>
                  </a:ext>
                </a:extLst>
              </a:tr>
            </a:tbl>
          </a:graphicData>
        </a:graphic>
      </p:graphicFrame>
      <p:pic>
        <p:nvPicPr>
          <p:cNvPr id="5" name="Imagen 4">
            <a:extLst>
              <a:ext uri="{FF2B5EF4-FFF2-40B4-BE49-F238E27FC236}">
                <a16:creationId xmlns:a16="http://schemas.microsoft.com/office/drawing/2014/main" id="{0CE50342-AE74-1472-2E8E-A46EB005AFC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824" r="9474"/>
          <a:stretch/>
        </p:blipFill>
        <p:spPr>
          <a:xfrm>
            <a:off x="2722973" y="802666"/>
            <a:ext cx="1327092" cy="1417160"/>
          </a:xfrm>
          <a:prstGeom prst="rect">
            <a:avLst/>
          </a:prstGeom>
        </p:spPr>
      </p:pic>
      <p:pic>
        <p:nvPicPr>
          <p:cNvPr id="6" name="Imagen 5" descr="Un dibujo animado&#10;&#10;Descripción generada automáticamente con confianza baja">
            <a:extLst>
              <a:ext uri="{FF2B5EF4-FFF2-40B4-BE49-F238E27FC236}">
                <a16:creationId xmlns:a16="http://schemas.microsoft.com/office/drawing/2014/main" id="{5FDA4A64-FEFD-BFA2-BE0A-F04A2217762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56" b="9173"/>
          <a:stretch/>
        </p:blipFill>
        <p:spPr bwMode="auto">
          <a:xfrm>
            <a:off x="5073706" y="772037"/>
            <a:ext cx="1848667" cy="1478418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1BDA1F7B-B94C-ED2A-174D-CC72386ED37D}"/>
              </a:ext>
            </a:extLst>
          </p:cNvPr>
          <p:cNvSpPr txBox="1"/>
          <p:nvPr/>
        </p:nvSpPr>
        <p:spPr>
          <a:xfrm>
            <a:off x="2059095" y="2184777"/>
            <a:ext cx="276685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RNA dependent RNA polymerase </a:t>
            </a:r>
          </a:p>
          <a:p>
            <a:r>
              <a:rPr lang="en-US" sz="1000" dirty="0"/>
              <a:t>of a human </a:t>
            </a:r>
            <a:r>
              <a:rPr lang="en-US" sz="1000" dirty="0" err="1"/>
              <a:t>picorbirnavirus</a:t>
            </a:r>
            <a:r>
              <a:rPr lang="en-US" sz="1000" dirty="0"/>
              <a:t> (5I61)</a:t>
            </a:r>
            <a:endParaRPr lang="en-GB" sz="10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C291C666-B6F2-B474-E327-F2592A365778}"/>
              </a:ext>
            </a:extLst>
          </p:cNvPr>
          <p:cNvSpPr txBox="1"/>
          <p:nvPr/>
        </p:nvSpPr>
        <p:spPr>
          <a:xfrm>
            <a:off x="4924803" y="2184777"/>
            <a:ext cx="234239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RNA dependent RNA polymerase </a:t>
            </a:r>
          </a:p>
          <a:p>
            <a:r>
              <a:rPr lang="en-US" sz="1000" dirty="0"/>
              <a:t>of Botrytis narnavirus 1</a:t>
            </a:r>
            <a:endParaRPr lang="en-GB" sz="1000" dirty="0"/>
          </a:p>
        </p:txBody>
      </p:sp>
      <p:pic>
        <p:nvPicPr>
          <p:cNvPr id="9" name="Imagen 8" descr="Un dibujo de una persona&#10;&#10;Descripción generada automáticamente con confianza media">
            <a:extLst>
              <a:ext uri="{FF2B5EF4-FFF2-40B4-BE49-F238E27FC236}">
                <a16:creationId xmlns:a16="http://schemas.microsoft.com/office/drawing/2014/main" id="{373CF106-717C-26D5-5FB3-AF42901F622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77" b="16472"/>
          <a:stretch/>
        </p:blipFill>
        <p:spPr bwMode="auto">
          <a:xfrm>
            <a:off x="7767400" y="772037"/>
            <a:ext cx="1983105" cy="1478418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2DE02384-BC50-5CC5-C900-0CB49875E76B}"/>
              </a:ext>
            </a:extLst>
          </p:cNvPr>
          <p:cNvSpPr txBox="1"/>
          <p:nvPr/>
        </p:nvSpPr>
        <p:spPr>
          <a:xfrm>
            <a:off x="7473141" y="2184777"/>
            <a:ext cx="278571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RNA dependent RNA polymerase </a:t>
            </a:r>
          </a:p>
          <a:p>
            <a:r>
              <a:rPr lang="en-US" sz="1000" dirty="0"/>
              <a:t>of Botrytis cinerea narnavirus 1</a:t>
            </a:r>
            <a:endParaRPr lang="en-GB" sz="1000" dirty="0"/>
          </a:p>
        </p:txBody>
      </p:sp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id="{F3B7C61B-847D-2EAC-86EA-E698449F40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5964671"/>
              </p:ext>
            </p:extLst>
          </p:nvPr>
        </p:nvGraphicFramePr>
        <p:xfrm>
          <a:off x="3049149" y="2651140"/>
          <a:ext cx="5418666" cy="38629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968034331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3209201285"/>
                    </a:ext>
                  </a:extLst>
                </a:gridCol>
              </a:tblGrid>
              <a:tr h="1931474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3654454"/>
                  </a:ext>
                </a:extLst>
              </a:tr>
              <a:tr h="1931474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5897058"/>
                  </a:ext>
                </a:extLst>
              </a:tr>
            </a:tbl>
          </a:graphicData>
        </a:graphic>
      </p:graphicFrame>
      <p:pic>
        <p:nvPicPr>
          <p:cNvPr id="3" name="Imagen 2">
            <a:extLst>
              <a:ext uri="{FF2B5EF4-FFF2-40B4-BE49-F238E27FC236}">
                <a16:creationId xmlns:a16="http://schemas.microsoft.com/office/drawing/2014/main" id="{CD8584C4-F34A-0074-78D6-663858A3713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69741" y="2776299"/>
            <a:ext cx="1424786" cy="1428339"/>
          </a:xfrm>
          <a:prstGeom prst="rect">
            <a:avLst/>
          </a:prstGeom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23EEF46F-B9C1-B317-2E42-C5EA1531834B}"/>
              </a:ext>
            </a:extLst>
          </p:cNvPr>
          <p:cNvSpPr txBox="1"/>
          <p:nvPr/>
        </p:nvSpPr>
        <p:spPr>
          <a:xfrm>
            <a:off x="3629770" y="4202571"/>
            <a:ext cx="1495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Aldolase (d1qo5b)</a:t>
            </a:r>
          </a:p>
        </p:txBody>
      </p:sp>
      <p:pic>
        <p:nvPicPr>
          <p:cNvPr id="20" name="Imagen 19">
            <a:extLst>
              <a:ext uri="{FF2B5EF4-FFF2-40B4-BE49-F238E27FC236}">
                <a16:creationId xmlns:a16="http://schemas.microsoft.com/office/drawing/2014/main" id="{4D3024D9-41B0-0544-CD06-7B3D3C62F9D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18110" y="4642413"/>
            <a:ext cx="1047684" cy="1440035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E944A4F5-7DA2-94C7-F788-E3293C39E517}"/>
              </a:ext>
            </a:extLst>
          </p:cNvPr>
          <p:cNvSpPr txBox="1"/>
          <p:nvPr/>
        </p:nvSpPr>
        <p:spPr>
          <a:xfrm>
            <a:off x="3049149" y="6079231"/>
            <a:ext cx="268341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vp51 in white spot syndrome virus capsid (7XF2)</a:t>
            </a:r>
            <a:endParaRPr lang="en-GB" sz="1000" dirty="0"/>
          </a:p>
        </p:txBody>
      </p:sp>
      <p:pic>
        <p:nvPicPr>
          <p:cNvPr id="22" name="Imagen 21" descr="Un dibujo de una persona&#10;&#10;Descripción generada automáticamente con confianza media">
            <a:extLst>
              <a:ext uri="{FF2B5EF4-FFF2-40B4-BE49-F238E27FC236}">
                <a16:creationId xmlns:a16="http://schemas.microsoft.com/office/drawing/2014/main" id="{39A811CB-DB12-D6CD-C921-5E055C5DBC9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61194" y="4680858"/>
            <a:ext cx="1363145" cy="1363145"/>
          </a:xfrm>
          <a:prstGeom prst="rect">
            <a:avLst/>
          </a:prstGeom>
          <a:noFill/>
          <a:ln>
            <a:noFill/>
          </a:ln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901D34D8-B84B-A25E-D376-E858E692C1CF}"/>
              </a:ext>
            </a:extLst>
          </p:cNvPr>
          <p:cNvSpPr txBox="1"/>
          <p:nvPr/>
        </p:nvSpPr>
        <p:spPr>
          <a:xfrm>
            <a:off x="5780858" y="6079231"/>
            <a:ext cx="268695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/>
              <a:t>Hypothetical protein of </a:t>
            </a:r>
          </a:p>
          <a:p>
            <a:pPr algn="ctr"/>
            <a:r>
              <a:rPr lang="en-US" sz="1000" dirty="0"/>
              <a:t>Botrytis cinerea narnavirus 1</a:t>
            </a:r>
            <a:endParaRPr lang="en-GB" sz="1000" dirty="0"/>
          </a:p>
        </p:txBody>
      </p:sp>
      <p:pic>
        <p:nvPicPr>
          <p:cNvPr id="24" name="Imagen 23" descr="Un dibujo de una persona&#10;&#10;Descripción generada automáticamente con confianza baja">
            <a:extLst>
              <a:ext uri="{FF2B5EF4-FFF2-40B4-BE49-F238E27FC236}">
                <a16:creationId xmlns:a16="http://schemas.microsoft.com/office/drawing/2014/main" id="{BCA99AB5-49B9-0F2A-91D1-B5D4B13FC3E8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54561" y="2702261"/>
            <a:ext cx="1576414" cy="1576414"/>
          </a:xfrm>
          <a:prstGeom prst="rect">
            <a:avLst/>
          </a:prstGeom>
          <a:noFill/>
          <a:ln>
            <a:noFill/>
          </a:ln>
        </p:spPr>
      </p:pic>
      <p:sp>
        <p:nvSpPr>
          <p:cNvPr id="25" name="CuadroTexto 24">
            <a:extLst>
              <a:ext uri="{FF2B5EF4-FFF2-40B4-BE49-F238E27FC236}">
                <a16:creationId xmlns:a16="http://schemas.microsoft.com/office/drawing/2014/main" id="{6C876F34-324C-D313-E08A-A9385122A24E}"/>
              </a:ext>
            </a:extLst>
          </p:cNvPr>
          <p:cNvSpPr txBox="1"/>
          <p:nvPr/>
        </p:nvSpPr>
        <p:spPr>
          <a:xfrm>
            <a:off x="5745981" y="4125626"/>
            <a:ext cx="279314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/>
              <a:t>Hypothetical protein of </a:t>
            </a:r>
          </a:p>
          <a:p>
            <a:pPr algn="ctr"/>
            <a:r>
              <a:rPr lang="en-US" sz="1000" dirty="0"/>
              <a:t>Botrytis </a:t>
            </a:r>
            <a:r>
              <a:rPr lang="en-US" sz="1000" dirty="0" err="1"/>
              <a:t>narnavirus</a:t>
            </a:r>
            <a:r>
              <a:rPr lang="en-US" sz="1000" dirty="0"/>
              <a:t> 1</a:t>
            </a:r>
            <a:endParaRPr lang="en-GB" sz="1000" dirty="0"/>
          </a:p>
        </p:txBody>
      </p:sp>
      <p:sp>
        <p:nvSpPr>
          <p:cNvPr id="11" name="Rectángulo 10"/>
          <p:cNvSpPr/>
          <p:nvPr/>
        </p:nvSpPr>
        <p:spPr>
          <a:xfrm>
            <a:off x="182215" y="86091"/>
            <a:ext cx="1182756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</a:t>
            </a:r>
            <a:r>
              <a:rPr lang="en-US" b="1"/>
              <a:t>Figure S4</a:t>
            </a:r>
            <a:r>
              <a:rPr lang="en-US" b="1" dirty="0"/>
              <a:t>. </a:t>
            </a:r>
            <a:r>
              <a:rPr lang="en-US" dirty="0"/>
              <a:t>Predicted tertiary structures of </a:t>
            </a:r>
            <a:r>
              <a:rPr lang="en-US" dirty="0" err="1"/>
              <a:t>RdRp</a:t>
            </a:r>
            <a:r>
              <a:rPr lang="en-US" dirty="0"/>
              <a:t> and HP proteins of BNV1 and BcNV1, in comparison with other proteins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9276374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78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RUIZ PADILLA</dc:creator>
  <cp:lastModifiedBy>MDPI</cp:lastModifiedBy>
  <cp:revision>9</cp:revision>
  <dcterms:created xsi:type="dcterms:W3CDTF">2024-09-02T16:49:02Z</dcterms:created>
  <dcterms:modified xsi:type="dcterms:W3CDTF">2024-10-21T04:26:01Z</dcterms:modified>
</cp:coreProperties>
</file>